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sv-S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1BA8283-204D-4F36-BA46-9C9AF5A6BC7F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82217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D906FD4-E0C2-42E9-939E-37A35CA06F0B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35222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FAB9EAC-66F6-4227-A0AA-6BFA6B182E01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24710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610336-BC5C-46A5-82F1-6C418EECFEFA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95387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DF50631-ECE0-42CC-AF21-AF071F3BB72D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53935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7350E46-12C9-4153-87B9-EAC6E0175C38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18399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470D87A-7929-4DEE-8A4E-D9B30FD0D974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0273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8C9CCBB-B5BF-4D49-AEDE-2661F3BECD81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72928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0D1FDF-2CD0-4D8B-8944-4E2243343745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68096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2C213A4-052B-4C12-817B-4E4146640EB2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86497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492B02-0249-429F-BB24-230A1B5629B7}" type="slidenum">
              <a:rPr lang="sv-SE"/>
              <a:pPr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84698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sv-SE" smtClean="0"/>
              <a:t>Klicka här för att ändra format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sv-S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sv-S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45526E52-9DF8-4F86-A92F-C3AC05E0F72D}" type="slidenum">
              <a:rPr lang="sv-SE"/>
              <a:pPr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cs typeface="Arial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 Box 417"/>
          <p:cNvSpPr txBox="1">
            <a:spLocks noChangeArrowheads="1"/>
          </p:cNvSpPr>
          <p:nvPr/>
        </p:nvSpPr>
        <p:spPr bwMode="auto">
          <a:xfrm>
            <a:off x="303213" y="6256338"/>
            <a:ext cx="8445500" cy="611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/>
              <a:t>Table 1. </a:t>
            </a:r>
            <a:r>
              <a:rPr lang="en-US" sz="1600"/>
              <a:t>The detailed characteristics of patients’ immune and virological status in relation 	to the levels of anti-flagellin and anti-measles IgG.</a:t>
            </a:r>
            <a:endParaRPr lang="sv-SE" sz="1600"/>
          </a:p>
        </p:txBody>
      </p:sp>
      <p:graphicFrame>
        <p:nvGraphicFramePr>
          <p:cNvPr id="3075" name="Group 3"/>
          <p:cNvGraphicFramePr>
            <a:graphicFrameLocks noGrp="1"/>
          </p:cNvGraphicFramePr>
          <p:nvPr/>
        </p:nvGraphicFramePr>
        <p:xfrm>
          <a:off x="1403350" y="1917700"/>
          <a:ext cx="6200775" cy="3093720"/>
        </p:xfrm>
        <a:graphic>
          <a:graphicData uri="http://schemas.openxmlformats.org/drawingml/2006/table">
            <a:tbl>
              <a:tblPr/>
              <a:tblGrid>
                <a:gridCol w="544513"/>
                <a:gridCol w="1255712"/>
                <a:gridCol w="965200"/>
                <a:gridCol w="1195388"/>
                <a:gridCol w="647700"/>
                <a:gridCol w="1592262"/>
              </a:tblGrid>
              <a:tr h="31273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nb-NO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nb-NO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b-NO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at  #</a:t>
                      </a: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 Anti-Measles </a:t>
                      </a:r>
                      <a:r>
                        <a:rPr kumimoji="0" lang="en-US" sz="1000" b="1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IgG</a:t>
                      </a:r>
                      <a:endParaRPr kumimoji="0" lang="sv-SE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(</a:t>
                      </a:r>
                      <a:r>
                        <a:rPr kumimoji="0" lang="en-US" sz="1000" b="1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mlU</a:t>
                      </a:r>
                      <a:r>
                        <a:rPr kumimoji="0" lang="en-US" sz="10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/ml)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1" i="1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Anti-flagellin IgG(OD)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CD4 T cells counts(cells/ul)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CD4%</a:t>
                      </a:r>
                      <a:endParaRPr kumimoji="0" lang="sv-SE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Viral Load (copies/ml)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6200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38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7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548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2900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90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3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26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530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63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2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688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39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65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8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648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61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76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8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242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16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95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8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10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54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.3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0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521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29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36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7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486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92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93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3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90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60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0.18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2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1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Times New Roman" pitchFamily="18" charset="0"/>
                        </a:rPr>
                        <a:t>411000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formgivning">
  <a:themeElements>
    <a:clrScheme name="Standardformgivning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formgivning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formgivning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8</Words>
  <Application>Microsoft Office PowerPoint</Application>
  <PresentationFormat>Bildspel på skärmen (4:3)</PresentationFormat>
  <Paragraphs>7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Times New Roman</vt:lpstr>
      <vt:lpstr>Calibri</vt:lpstr>
      <vt:lpstr>Standardformgivning</vt:lpstr>
      <vt:lpstr>PowerPoint-presentation</vt:lpstr>
    </vt:vector>
  </TitlesOfParts>
  <Company>Karolinska Institu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Piotr Nowak</dc:creator>
  <cp:lastModifiedBy>Piotr</cp:lastModifiedBy>
  <cp:revision>2</cp:revision>
  <dcterms:created xsi:type="dcterms:W3CDTF">2011-03-26T22:28:58Z</dcterms:created>
  <dcterms:modified xsi:type="dcterms:W3CDTF">2012-04-25T21:43:57Z</dcterms:modified>
</cp:coreProperties>
</file>